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782CF1-5C9D-4FFF-9449-E93FFF7A9DF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B26B67-5799-4DB5-982E-9D6C60432CC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E46EB2-489F-44A5-AEEF-47E2DDA9D1B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530CFD-0EB1-4F9D-8069-636D68ED74F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300613-D5EF-40ED-97DD-9D143409A35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7B722F-738F-4676-83E3-A3221717D05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A7C44E-9F3D-4962-A242-5097D6E5B59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4D4D5A-01A3-42C7-92D7-D055253338B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52FC21-48E4-4CAE-AC4D-2492D5A86AB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97CECD-3AA7-48B0-BD84-9DAEDCB1D4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F4C3B3-878E-4D24-8826-9BEBAA259E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40BEDF-B3BB-4CDF-914A-70180CF8AE5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C7BCCA4-24BC-4140-9BC0-55615F644A6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6740640" y="3203640"/>
            <a:ext cx="71280" cy="71280"/>
            <a:chOff x="6740640" y="3203640"/>
            <a:chExt cx="71280" cy="71280"/>
          </a:xfrm>
        </p:grpSpPr>
        <p:sp>
          <p:nvSpPr>
            <p:cNvPr id="42" name=""/>
            <p:cNvSpPr/>
            <p:nvPr/>
          </p:nvSpPr>
          <p:spPr>
            <a:xfrm>
              <a:off x="6773760" y="3203640"/>
              <a:ext cx="0" cy="71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 flipH="1">
              <a:off x="6740640" y="3203640"/>
              <a:ext cx="71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4" name=""/>
          <p:cNvGrpSpPr/>
          <p:nvPr/>
        </p:nvGrpSpPr>
        <p:grpSpPr>
          <a:xfrm>
            <a:off x="6240600" y="2577960"/>
            <a:ext cx="71280" cy="71640"/>
            <a:chOff x="6240600" y="2577960"/>
            <a:chExt cx="71280" cy="71640"/>
          </a:xfrm>
        </p:grpSpPr>
        <p:sp>
          <p:nvSpPr>
            <p:cNvPr id="45" name=""/>
            <p:cNvSpPr/>
            <p:nvPr/>
          </p:nvSpPr>
          <p:spPr>
            <a:xfrm>
              <a:off x="6273720" y="2577960"/>
              <a:ext cx="0" cy="71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 flipH="1">
              <a:off x="6240600" y="2577960"/>
              <a:ext cx="71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7" name=""/>
          <p:cNvGrpSpPr/>
          <p:nvPr/>
        </p:nvGrpSpPr>
        <p:grpSpPr>
          <a:xfrm>
            <a:off x="5730840" y="1733400"/>
            <a:ext cx="71280" cy="71640"/>
            <a:chOff x="5730840" y="1733400"/>
            <a:chExt cx="71280" cy="71640"/>
          </a:xfrm>
        </p:grpSpPr>
        <p:sp>
          <p:nvSpPr>
            <p:cNvPr id="48" name=""/>
            <p:cNvSpPr/>
            <p:nvPr/>
          </p:nvSpPr>
          <p:spPr>
            <a:xfrm>
              <a:off x="5763960" y="1733400"/>
              <a:ext cx="0" cy="71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 flipH="1">
              <a:off x="5730840" y="1733400"/>
              <a:ext cx="71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0" name=""/>
          <p:cNvGrpSpPr/>
          <p:nvPr/>
        </p:nvGrpSpPr>
        <p:grpSpPr>
          <a:xfrm>
            <a:off x="5234040" y="2579760"/>
            <a:ext cx="71280" cy="71280"/>
            <a:chOff x="5234040" y="2579760"/>
            <a:chExt cx="71280" cy="71280"/>
          </a:xfrm>
        </p:grpSpPr>
        <p:sp>
          <p:nvSpPr>
            <p:cNvPr id="51" name=""/>
            <p:cNvSpPr/>
            <p:nvPr/>
          </p:nvSpPr>
          <p:spPr>
            <a:xfrm>
              <a:off x="5267160" y="2579760"/>
              <a:ext cx="0" cy="71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 flipH="1">
              <a:off x="5234040" y="2579760"/>
              <a:ext cx="71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3" name=""/>
          <p:cNvGrpSpPr/>
          <p:nvPr/>
        </p:nvGrpSpPr>
        <p:grpSpPr>
          <a:xfrm>
            <a:off x="4767120" y="3208320"/>
            <a:ext cx="71280" cy="71280"/>
            <a:chOff x="4767120" y="3208320"/>
            <a:chExt cx="71280" cy="71280"/>
          </a:xfrm>
        </p:grpSpPr>
        <p:sp>
          <p:nvSpPr>
            <p:cNvPr id="54" name=""/>
            <p:cNvSpPr/>
            <p:nvPr/>
          </p:nvSpPr>
          <p:spPr>
            <a:xfrm>
              <a:off x="4800240" y="3208320"/>
              <a:ext cx="0" cy="71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 flipH="1">
              <a:off x="4767120" y="3208320"/>
              <a:ext cx="71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6" name=""/>
          <p:cNvGrpSpPr/>
          <p:nvPr/>
        </p:nvGrpSpPr>
        <p:grpSpPr>
          <a:xfrm>
            <a:off x="3749760" y="3619440"/>
            <a:ext cx="71280" cy="71640"/>
            <a:chOff x="3749760" y="3619440"/>
            <a:chExt cx="71280" cy="71640"/>
          </a:xfrm>
        </p:grpSpPr>
        <p:sp>
          <p:nvSpPr>
            <p:cNvPr id="57" name=""/>
            <p:cNvSpPr/>
            <p:nvPr/>
          </p:nvSpPr>
          <p:spPr>
            <a:xfrm>
              <a:off x="3782880" y="3619440"/>
              <a:ext cx="0" cy="71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 flipH="1">
              <a:off x="3749760" y="3619440"/>
              <a:ext cx="71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9" name=""/>
          <p:cNvGrpSpPr/>
          <p:nvPr/>
        </p:nvGrpSpPr>
        <p:grpSpPr>
          <a:xfrm>
            <a:off x="2444760" y="3097080"/>
            <a:ext cx="71280" cy="71640"/>
            <a:chOff x="2444760" y="3097080"/>
            <a:chExt cx="71280" cy="71640"/>
          </a:xfrm>
        </p:grpSpPr>
        <p:sp>
          <p:nvSpPr>
            <p:cNvPr id="60" name=""/>
            <p:cNvSpPr/>
            <p:nvPr/>
          </p:nvSpPr>
          <p:spPr>
            <a:xfrm>
              <a:off x="2477880" y="3097080"/>
              <a:ext cx="0" cy="71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 flipH="1">
              <a:off x="2444760" y="3097080"/>
              <a:ext cx="71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2" name=""/>
          <p:cNvGrpSpPr/>
          <p:nvPr/>
        </p:nvGrpSpPr>
        <p:grpSpPr>
          <a:xfrm>
            <a:off x="1863720" y="3789360"/>
            <a:ext cx="71280" cy="71280"/>
            <a:chOff x="1863720" y="3789360"/>
            <a:chExt cx="71280" cy="71280"/>
          </a:xfrm>
        </p:grpSpPr>
        <p:sp>
          <p:nvSpPr>
            <p:cNvPr id="63" name=""/>
            <p:cNvSpPr/>
            <p:nvPr/>
          </p:nvSpPr>
          <p:spPr>
            <a:xfrm>
              <a:off x="1896840" y="3789360"/>
              <a:ext cx="0" cy="71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 flipH="1">
              <a:off x="1863720" y="3789360"/>
              <a:ext cx="71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5" name=""/>
          <p:cNvGrpSpPr/>
          <p:nvPr/>
        </p:nvGrpSpPr>
        <p:grpSpPr>
          <a:xfrm>
            <a:off x="1301760" y="3894120"/>
            <a:ext cx="71280" cy="71280"/>
            <a:chOff x="1301760" y="3894120"/>
            <a:chExt cx="71280" cy="71280"/>
          </a:xfrm>
        </p:grpSpPr>
        <p:sp>
          <p:nvSpPr>
            <p:cNvPr id="66" name=""/>
            <p:cNvSpPr/>
            <p:nvPr/>
          </p:nvSpPr>
          <p:spPr>
            <a:xfrm>
              <a:off x="1334880" y="3894120"/>
              <a:ext cx="0" cy="71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 flipH="1">
              <a:off x="1301760" y="3894120"/>
              <a:ext cx="71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8" name=""/>
          <p:cNvSpPr/>
          <p:nvPr/>
        </p:nvSpPr>
        <p:spPr>
          <a:xfrm>
            <a:off x="1217520" y="3922560"/>
            <a:ext cx="247680" cy="14616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1785960" y="3813120"/>
            <a:ext cx="247680" cy="255600"/>
          </a:xfrm>
          <a:prstGeom prst="rect">
            <a:avLst/>
          </a:prstGeom>
          <a:gradFill rotWithShape="0">
            <a:gsLst>
              <a:gs pos="0">
                <a:srgbClr val="5f5f5f"/>
              </a:gs>
              <a:gs pos="100000">
                <a:srgbClr val="b2b2b2"/>
              </a:gs>
            </a:gsLst>
            <a:lin ang="13500000"/>
          </a:gra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2355840" y="3124080"/>
            <a:ext cx="246240" cy="944640"/>
          </a:xfrm>
          <a:prstGeom prst="rect">
            <a:avLst/>
          </a:prstGeom>
          <a:gradFill rotWithShape="0">
            <a:gsLst>
              <a:gs pos="0">
                <a:srgbClr val="1b1b1b"/>
              </a:gs>
              <a:gs pos="100000">
                <a:srgbClr val="000000"/>
              </a:gs>
            </a:gsLst>
            <a:lin ang="13500000"/>
          </a:gra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3659040" y="3651120"/>
            <a:ext cx="247680" cy="417600"/>
          </a:xfrm>
          <a:prstGeom prst="rect">
            <a:avLst/>
          </a:prstGeom>
          <a:blipFill rotWithShape="0">
            <a:blip r:embed="rId1"/>
            <a:srcRect/>
            <a:tile tx="0" ty="0" sx="100000" sy="100000" algn="ctr"/>
          </a:blip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2" name=""/>
          <p:cNvGrpSpPr/>
          <p:nvPr/>
        </p:nvGrpSpPr>
        <p:grpSpPr>
          <a:xfrm>
            <a:off x="4179960" y="3743280"/>
            <a:ext cx="247680" cy="317520"/>
            <a:chOff x="4179960" y="3743280"/>
            <a:chExt cx="247680" cy="317520"/>
          </a:xfrm>
        </p:grpSpPr>
        <p:grpSp>
          <p:nvGrpSpPr>
            <p:cNvPr id="73" name=""/>
            <p:cNvGrpSpPr/>
            <p:nvPr/>
          </p:nvGrpSpPr>
          <p:grpSpPr>
            <a:xfrm>
              <a:off x="4257720" y="3743280"/>
              <a:ext cx="71280" cy="71640"/>
              <a:chOff x="4257720" y="3743280"/>
              <a:chExt cx="71280" cy="71640"/>
            </a:xfrm>
          </p:grpSpPr>
          <p:sp>
            <p:nvSpPr>
              <p:cNvPr id="74" name=""/>
              <p:cNvSpPr/>
              <p:nvPr/>
            </p:nvSpPr>
            <p:spPr>
              <a:xfrm>
                <a:off x="4290840" y="3743280"/>
                <a:ext cx="0" cy="71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840" bIns="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 flipH="1">
                <a:off x="4257720" y="3743280"/>
                <a:ext cx="71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6" name=""/>
            <p:cNvSpPr/>
            <p:nvPr/>
          </p:nvSpPr>
          <p:spPr>
            <a:xfrm>
              <a:off x="4179960" y="3770280"/>
              <a:ext cx="247680" cy="290520"/>
            </a:xfrm>
            <a:prstGeom prst="rect">
              <a:avLst/>
            </a:prstGeom>
            <a:blipFill rotWithShape="0">
              <a:blip r:embed="rId2"/>
              <a:srcRect/>
              <a:tile tx="0" ty="0" sx="100000" sy="100000" algn="ctr"/>
            </a:blip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7" name=""/>
          <p:cNvSpPr/>
          <p:nvPr/>
        </p:nvSpPr>
        <p:spPr>
          <a:xfrm>
            <a:off x="4683240" y="3233880"/>
            <a:ext cx="247680" cy="834840"/>
          </a:xfrm>
          <a:prstGeom prst="rect">
            <a:avLst/>
          </a:prstGeom>
          <a:blipFill rotWithShape="0">
            <a:blip r:embed="rId3"/>
            <a:srcRect/>
            <a:tile tx="0" ty="0" sx="100000" sy="100000" algn="ctr"/>
          </a:blip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5159520" y="2616120"/>
            <a:ext cx="233280" cy="1452600"/>
          </a:xfrm>
          <a:prstGeom prst="rect">
            <a:avLst/>
          </a:prstGeom>
          <a:blipFill rotWithShape="0">
            <a:blip r:embed="rId4"/>
            <a:srcRect/>
            <a:tile tx="0" ty="0" sx="100000" sy="100000" algn="ctr"/>
          </a:blip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5651640" y="1762200"/>
            <a:ext cx="245880" cy="2306520"/>
          </a:xfrm>
          <a:prstGeom prst="rect">
            <a:avLst/>
          </a:prstGeom>
          <a:blipFill rotWithShape="0">
            <a:blip r:embed="rId5"/>
            <a:srcRect/>
            <a:tile tx="0" ty="0" sx="100000" sy="100000" algn="ctr"/>
          </a:blip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6154560" y="2616120"/>
            <a:ext cx="247680" cy="1452600"/>
          </a:xfrm>
          <a:prstGeom prst="rect">
            <a:avLst/>
          </a:prstGeom>
          <a:blipFill rotWithShape="0">
            <a:blip r:embed="rId6"/>
            <a:srcRect/>
            <a:tile tx="0" ty="0" sx="100000" sy="100000" algn="ctr"/>
          </a:blip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6657840" y="3233880"/>
            <a:ext cx="247680" cy="834840"/>
          </a:xfrm>
          <a:prstGeom prst="rect">
            <a:avLst/>
          </a:prstGeom>
          <a:blipFill rotWithShape="0">
            <a:blip r:embed="rId7"/>
            <a:srcRect/>
            <a:tile tx="0" ty="0" sx="100000" sy="100000" algn="ctr"/>
          </a:blip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2" name=""/>
          <p:cNvGrpSpPr/>
          <p:nvPr/>
        </p:nvGrpSpPr>
        <p:grpSpPr>
          <a:xfrm>
            <a:off x="7205760" y="1778040"/>
            <a:ext cx="71280" cy="71280"/>
            <a:chOff x="7205760" y="1778040"/>
            <a:chExt cx="71280" cy="71280"/>
          </a:xfrm>
        </p:grpSpPr>
        <p:sp>
          <p:nvSpPr>
            <p:cNvPr id="83" name=""/>
            <p:cNvSpPr/>
            <p:nvPr/>
          </p:nvSpPr>
          <p:spPr>
            <a:xfrm>
              <a:off x="7238880" y="1778040"/>
              <a:ext cx="0" cy="71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 flipH="1">
              <a:off x="7205760" y="1778040"/>
              <a:ext cx="71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5" name=""/>
          <p:cNvSpPr/>
          <p:nvPr/>
        </p:nvSpPr>
        <p:spPr>
          <a:xfrm>
            <a:off x="7116840" y="1808280"/>
            <a:ext cx="247680" cy="2251080"/>
          </a:xfrm>
          <a:prstGeom prst="rect">
            <a:avLst/>
          </a:prstGeom>
          <a:blipFill rotWithShape="0">
            <a:blip r:embed="rId8"/>
            <a:srcRect/>
            <a:tile tx="0" ty="0" sx="100000" sy="100000" algn="ctr"/>
          </a:blip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1049400" y="1308240"/>
            <a:ext cx="1440" cy="276048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973080" y="2687760"/>
            <a:ext cx="73080" cy="144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977760" y="1308240"/>
            <a:ext cx="73080" cy="144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996840" y="4068720"/>
            <a:ext cx="7275600" cy="180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839160" y="3905280"/>
            <a:ext cx="99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641520" y="254484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2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636840" y="1163520"/>
            <a:ext cx="298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5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1124280" y="4195800"/>
            <a:ext cx="416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U2O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1631880" y="4195800"/>
            <a:ext cx="544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SaOS-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2298600" y="4205160"/>
            <a:ext cx="389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it-IT" sz="1200" spc="-1" strike="noStrike">
                <a:solidFill>
                  <a:srgbClr val="000000"/>
                </a:solidFill>
                <a:latin typeface="Arial"/>
              </a:rPr>
              <a:t>Hobi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7710120" y="4189320"/>
            <a:ext cx="4150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MCF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7802640" y="4017960"/>
            <a:ext cx="247680" cy="46080"/>
          </a:xfrm>
          <a:prstGeom prst="rect">
            <a:avLst/>
          </a:prstGeom>
          <a:solidFill>
            <a:srgbClr val="00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3649680" y="4149720"/>
            <a:ext cx="704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 rot="16200000">
            <a:off x="-1057320" y="2502000"/>
            <a:ext cx="2838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Arial"/>
              </a:rPr>
              <a:t>Relative Slug mRNA level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2886120" y="1425600"/>
            <a:ext cx="247680" cy="2644920"/>
          </a:xfrm>
          <a:prstGeom prst="rect">
            <a:avLst/>
          </a:prstGeom>
          <a:gradFill rotWithShape="0">
            <a:gsLst>
              <a:gs pos="0">
                <a:srgbClr val="c1c1c1"/>
              </a:gs>
              <a:gs pos="100000">
                <a:srgbClr val="808080">
                  <a:alpha val="30196"/>
                </a:srgbClr>
              </a:gs>
            </a:gsLst>
            <a:lin ang="13500000"/>
          </a:gra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1" name=""/>
          <p:cNvGrpSpPr/>
          <p:nvPr/>
        </p:nvGrpSpPr>
        <p:grpSpPr>
          <a:xfrm>
            <a:off x="2970360" y="1351080"/>
            <a:ext cx="71280" cy="71280"/>
            <a:chOff x="2970360" y="1351080"/>
            <a:chExt cx="71280" cy="71280"/>
          </a:xfrm>
        </p:grpSpPr>
        <p:sp>
          <p:nvSpPr>
            <p:cNvPr id="102" name=""/>
            <p:cNvSpPr/>
            <p:nvPr/>
          </p:nvSpPr>
          <p:spPr>
            <a:xfrm>
              <a:off x="3003480" y="1351080"/>
              <a:ext cx="0" cy="71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 flipH="1">
              <a:off x="2970360" y="1351080"/>
              <a:ext cx="71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4" name=""/>
          <p:cNvSpPr/>
          <p:nvPr/>
        </p:nvSpPr>
        <p:spPr>
          <a:xfrm>
            <a:off x="2784600" y="4211640"/>
            <a:ext cx="11271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CAL7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4148280" y="4149720"/>
            <a:ext cx="647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4662360" y="4149720"/>
            <a:ext cx="64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5132520" y="4149720"/>
            <a:ext cx="649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5645160" y="4149720"/>
            <a:ext cx="633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6149880" y="4149720"/>
            <a:ext cx="720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6654960" y="4149720"/>
            <a:ext cx="79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7101000" y="4149720"/>
            <a:ext cx="71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4284720" y="6200640"/>
            <a:ext cx="1439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S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3519360" y="4437000"/>
            <a:ext cx="3981600" cy="180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5132520" y="4451400"/>
            <a:ext cx="704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it-IT" sz="1400" spc="-1" strike="noStrike">
                <a:solidFill>
                  <a:srgbClr val="000000"/>
                </a:solidFill>
                <a:latin typeface="Arial"/>
              </a:rPr>
              <a:t>hOB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1066680" y="4495680"/>
            <a:ext cx="2210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990720" y="4495680"/>
            <a:ext cx="2819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it-IT" sz="1400" spc="-1" strike="noStrike">
                <a:solidFill>
                  <a:srgbClr val="000000"/>
                </a:solidFill>
                <a:latin typeface="Arial"/>
              </a:rPr>
              <a:t>Osteoblast-like cell lin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7238880" y="4648320"/>
            <a:ext cx="1371600" cy="631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it-IT" sz="1400" spc="-1" strike="noStrike">
                <a:solidFill>
                  <a:srgbClr val="000000"/>
                </a:solidFill>
                <a:latin typeface="Arial"/>
              </a:rPr>
              <a:t>Breast cancer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it-IT" sz="1400" spc="-1" strike="noStrike">
                <a:solidFill>
                  <a:srgbClr val="000000"/>
                </a:solidFill>
                <a:latin typeface="Arial"/>
              </a:rPr>
              <a:t>cell line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7696080" y="4572000"/>
            <a:ext cx="457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1-11T16:22:39Z</dcterms:created>
  <dc:creator>Biologia Molecolare</dc:creator>
  <dc:description/>
  <dc:language>en-US</dc:language>
  <cp:lastModifiedBy>eMac</cp:lastModifiedBy>
  <dcterms:modified xsi:type="dcterms:W3CDTF">2010-02-02T08:52:20Z</dcterms:modified>
  <cp:revision>29</cp:revision>
  <dc:subject/>
  <dc:title>Diapositiva 1</dc:title>
</cp:coreProperties>
</file>